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8080AA"/>
    <a:srgbClr val="747489"/>
    <a:srgbClr val="0000FF"/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2" d="100"/>
          <a:sy n="102" d="100"/>
        </p:scale>
        <p:origin x="83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0DA8388-112A-4BF1-8E3E-87E869DD9E19}" type="datetimeFigureOut">
              <a:rPr lang="en-IN" smtClean="0"/>
              <a:t>21-11-2025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594A8CA-9C80-4593-B7AF-CCC5E09B941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873036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B245C0-4FC0-59A7-4747-F3A5DE44BD1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55ED4C8-D11E-E244-9808-E63D951035D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A43424-133C-49F7-E1A2-B66ABB8ED2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50456-8D04-4586-B68D-4D21B75477CD}" type="datetimeFigureOut">
              <a:rPr lang="en-IN" smtClean="0"/>
              <a:t>21-11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EFBB77-7C38-25A9-6EF2-51F4358CB4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8AB76CB-4BED-79EC-5818-ED7EECA5A8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401DE-7067-4384-AEA1-C7196EDA3ED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04845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384E1D-E093-F54A-42D8-FD0401F234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60B0621-3356-E0CC-5E42-013D70B9A42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CC4474-18E0-0DE8-6F55-9C7367184C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50456-8D04-4586-B68D-4D21B75477CD}" type="datetimeFigureOut">
              <a:rPr lang="en-IN" smtClean="0"/>
              <a:t>21-11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D0743C-668E-B5FF-6754-10ABB14772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E712B7-BB18-D646-C3E4-7E5688B7E4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401DE-7067-4384-AEA1-C7196EDA3ED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303474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7EA9225-41D1-A0B5-59E8-B70B3564583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9C93D0A-586D-4BD7-DD82-8FFD82AACB6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4276A7-F156-7A1F-88AA-19BD22AC69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50456-8D04-4586-B68D-4D21B75477CD}" type="datetimeFigureOut">
              <a:rPr lang="en-IN" smtClean="0"/>
              <a:t>21-11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5295C1-9E24-7852-7C2D-8A8BB6D705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349273-81D0-0EC4-4B34-FEEFD8CF6B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401DE-7067-4384-AEA1-C7196EDA3ED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654689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3CCD97-54ED-2EE6-41D5-BF6BA30508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63A24A5-4035-2D8F-D28C-54E9D318A4C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602D8D7-711B-F512-D1F3-C867A78E8E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50456-8D04-4586-B68D-4D21B75477CD}" type="datetimeFigureOut">
              <a:rPr lang="en-IN" smtClean="0"/>
              <a:t>21-11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58134AE-1550-16A0-FE78-CE17D1B926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BAAD4E-4BEB-D208-DA89-B586566061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401DE-7067-4384-AEA1-C7196EDA3ED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307767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3DD577-10E0-E20F-58E3-D165506BB9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596EBA5-A1D5-4970-B97E-51E23B50D7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C1B4C2-A2C4-9EAC-A485-2D8DB9AEFF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50456-8D04-4586-B68D-4D21B75477CD}" type="datetimeFigureOut">
              <a:rPr lang="en-IN" smtClean="0"/>
              <a:t>21-11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AE62E0-4DCD-CFED-2C77-386A027F45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FF9158-4E5F-7184-74AD-4BAE99F754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401DE-7067-4384-AEA1-C7196EDA3ED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929579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59A4E9-7FDE-FCB5-4266-572B27F862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BC97D4C-B9AB-7167-72E1-575F0AA2625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2F3953A-F407-A03A-DCAC-F6EDE20E3B1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B73BB2B-D577-C667-A797-CEE704B7F4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50456-8D04-4586-B68D-4D21B75477CD}" type="datetimeFigureOut">
              <a:rPr lang="en-IN" smtClean="0"/>
              <a:t>21-11-20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E81A2C7-AB09-CB71-4921-7D70FAFC0D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C01F3BD-DA0E-B9E9-382E-86B6E255D2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401DE-7067-4384-AEA1-C7196EDA3ED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536408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576FC0-2994-9356-74E0-0BA673220F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FB488BF-0A3D-D0AE-288D-E88B2C99E1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7AB0B31-494F-E2AC-C187-971FEC5C1B5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F4E0F1B-2878-2B92-B36D-040595F6A3B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7315992-A9D0-8D6E-7911-EB471502B66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8672671-D437-83AC-09B6-3FEFBC74DD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50456-8D04-4586-B68D-4D21B75477CD}" type="datetimeFigureOut">
              <a:rPr lang="en-IN" smtClean="0"/>
              <a:t>21-11-2025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A3CDBE5-78A9-F9AC-FFF5-CF86AD385C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BAF0308-7627-F7AB-CFAA-2636424DDB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401DE-7067-4384-AEA1-C7196EDA3ED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935283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7A186E-C3E6-FF77-7ADC-BC35619236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1FC656B-138D-CF25-F547-198562FED4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50456-8D04-4586-B68D-4D21B75477CD}" type="datetimeFigureOut">
              <a:rPr lang="en-IN" smtClean="0"/>
              <a:t>21-11-2025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BB941AD-A8D5-0561-9512-B2B1556C51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E529A22-E8A7-EF7A-ED9E-45728ABDBE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401DE-7067-4384-AEA1-C7196EDA3ED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543545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AE82CD0-8B8E-EB5A-4B85-42EF596012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50456-8D04-4586-B68D-4D21B75477CD}" type="datetimeFigureOut">
              <a:rPr lang="en-IN" smtClean="0"/>
              <a:t>21-11-2025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47CD444-7A7E-CFD2-DD49-4656418756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0433D6C-C9C9-0B2F-CFD0-FC804F560D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401DE-7067-4384-AEA1-C7196EDA3ED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765813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E6FD8D-03E3-4A53-2394-3988ADC636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B614B79-DE4B-F8C1-3E12-70E9B54B361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522E600-77F6-5D8D-FD91-1284D6EF4C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6C21386-4CD3-D2DC-CF5F-95A595BE8F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50456-8D04-4586-B68D-4D21B75477CD}" type="datetimeFigureOut">
              <a:rPr lang="en-IN" smtClean="0"/>
              <a:t>21-11-20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FDC38C1-99F1-EACB-163E-6C186EA7E1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25B3B61-2D8F-3FE7-4D82-26D16C5169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401DE-7067-4384-AEA1-C7196EDA3ED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801234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6786B5-720C-4EA1-3FC7-C8CC97F5FD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9068B81-BB45-DA04-39DE-65844B76AF9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09F235F-F608-7178-F65F-CE0E4168BAA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F82B937-9D6A-DAF5-D107-B623B31391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50456-8D04-4586-B68D-4D21B75477CD}" type="datetimeFigureOut">
              <a:rPr lang="en-IN" smtClean="0"/>
              <a:t>21-11-20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1395681-6F48-D7A8-E3E5-B96097EBF9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86D8CAE-50E4-C3B8-4EE6-5BB6D4551D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401DE-7067-4384-AEA1-C7196EDA3ED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274852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D2392B4-9930-1E97-6DA4-C61F64E73C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C06D56E-05CD-76FC-5B85-8A033412FA3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0CE463C-B00F-C373-C969-A3EE586CE0F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DA50456-8D04-4586-B68D-4D21B75477CD}" type="datetimeFigureOut">
              <a:rPr lang="en-IN" smtClean="0"/>
              <a:t>21-11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F3CB05-180F-5544-DEC3-583D2849A65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25A72E-5691-E5C5-D4F3-9264788F205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65401DE-7067-4384-AEA1-C7196EDA3ED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504603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black background with a black border and a white line&#10;&#10;AI-generated content may be incorrect.">
            <a:extLst>
              <a:ext uri="{FF2B5EF4-FFF2-40B4-BE49-F238E27FC236}">
                <a16:creationId xmlns:a16="http://schemas.microsoft.com/office/drawing/2014/main" id="{9CCF3964-5344-4ADB-2183-45B4D3C404A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97" t="1098" r="66009" b="4369"/>
          <a:stretch>
            <a:fillRect/>
          </a:stretch>
        </p:blipFill>
        <p:spPr>
          <a:xfrm>
            <a:off x="4591671" y="0"/>
            <a:ext cx="3790950" cy="60579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6B085099-CEE0-E693-389A-41005238687E}"/>
              </a:ext>
            </a:extLst>
          </p:cNvPr>
          <p:cNvSpPr txBox="1"/>
          <p:nvPr/>
        </p:nvSpPr>
        <p:spPr>
          <a:xfrm>
            <a:off x="188536" y="6230148"/>
            <a:ext cx="1200346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074738" indent="-1074738" algn="just"/>
            <a:r>
              <a:rPr lang="en-IN" b="1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Figure S1: </a:t>
            </a:r>
            <a:r>
              <a:rPr lang="en-US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WEE2 bound to co-crystallized MK1775 (yellow) and the docked MK1775 pose (green). The figure was generated in PyMOL using PDB structure 5VDK.</a:t>
            </a:r>
            <a:endParaRPr lang="en-IN" b="0" i="0" dirty="0">
              <a:solidFill>
                <a:srgbClr val="333333"/>
              </a:solidFill>
              <a:effectLst/>
              <a:highlight>
                <a:srgbClr val="FFFFFF"/>
              </a:highlight>
              <a:latin typeface="Times New Roman" panose="02020603050405020304" pitchFamily="18" charset="0"/>
              <a:ea typeface="Tahoma" panose="020B060403050404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2A3562D-F7C3-5536-522B-2CC86091141E}"/>
              </a:ext>
            </a:extLst>
          </p:cNvPr>
          <p:cNvSpPr txBox="1"/>
          <p:nvPr/>
        </p:nvSpPr>
        <p:spPr>
          <a:xfrm>
            <a:off x="2703588" y="5205649"/>
            <a:ext cx="25225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600" b="1" dirty="0">
                <a:solidFill>
                  <a:srgbClr val="8080AA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RT (PDB ID: 5VDK)</a:t>
            </a:r>
          </a:p>
        </p:txBody>
      </p: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045382D1-2B7B-08F3-95F2-415652A5352A}"/>
              </a:ext>
            </a:extLst>
          </p:cNvPr>
          <p:cNvCxnSpPr>
            <a:cxnSpLocks/>
          </p:cNvCxnSpPr>
          <p:nvPr/>
        </p:nvCxnSpPr>
        <p:spPr>
          <a:xfrm>
            <a:off x="4063770" y="2373242"/>
            <a:ext cx="136498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DE89F68E-1FD2-8E6C-A9E1-6AC0AD901811}"/>
              </a:ext>
            </a:extLst>
          </p:cNvPr>
          <p:cNvSpPr txBox="1"/>
          <p:nvPr/>
        </p:nvSpPr>
        <p:spPr>
          <a:xfrm>
            <a:off x="1750773" y="2179632"/>
            <a:ext cx="25769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N" sz="1600" dirty="0">
                <a:solidFill>
                  <a:srgbClr val="FFC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-crystalized MK1775</a:t>
            </a:r>
            <a:endParaRPr lang="en-IN" sz="1600" b="0" i="0" dirty="0">
              <a:solidFill>
                <a:srgbClr val="FFC000"/>
              </a:solidFill>
              <a:effectLst/>
              <a:highlight>
                <a:srgbClr val="FFFFFF"/>
              </a:highlight>
              <a:latin typeface="Helvetica Neue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8E7DD55-8B56-4621-439F-E630A34DDDD0}"/>
              </a:ext>
            </a:extLst>
          </p:cNvPr>
          <p:cNvSpPr txBox="1"/>
          <p:nvPr/>
        </p:nvSpPr>
        <p:spPr>
          <a:xfrm>
            <a:off x="2341710" y="2481790"/>
            <a:ext cx="19765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N" sz="16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cked MK1775</a:t>
            </a:r>
            <a:endParaRPr lang="en-IN" sz="1600" b="0" i="0" dirty="0">
              <a:solidFill>
                <a:srgbClr val="00B050"/>
              </a:solidFill>
              <a:effectLst/>
              <a:highlight>
                <a:srgbClr val="FFFFFF"/>
              </a:highlight>
              <a:latin typeface="Helvetica Neue"/>
            </a:endParaRPr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42705618-829E-298D-6067-EB1F153DF21A}"/>
              </a:ext>
            </a:extLst>
          </p:cNvPr>
          <p:cNvCxnSpPr>
            <a:cxnSpLocks/>
          </p:cNvCxnSpPr>
          <p:nvPr/>
        </p:nvCxnSpPr>
        <p:spPr>
          <a:xfrm flipV="1">
            <a:off x="4063770" y="2518186"/>
            <a:ext cx="1571554" cy="13288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8596431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86</TotalTime>
  <Words>41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Helvetica Neue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dmin</dc:creator>
  <cp:lastModifiedBy>Admin</cp:lastModifiedBy>
  <cp:revision>79</cp:revision>
  <dcterms:created xsi:type="dcterms:W3CDTF">2024-06-04T11:28:20Z</dcterms:created>
  <dcterms:modified xsi:type="dcterms:W3CDTF">2025-11-21T11:28:45Z</dcterms:modified>
</cp:coreProperties>
</file>